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63" r:id="rId6"/>
    <p:sldId id="262" r:id="rId7"/>
    <p:sldId id="261" r:id="rId8"/>
    <p:sldId id="265" r:id="rId9"/>
    <p:sldId id="259" r:id="rId10"/>
    <p:sldId id="264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4" userDrawn="1">
          <p15:clr>
            <a:srgbClr val="A4A3A4"/>
          </p15:clr>
        </p15:guide>
        <p15:guide id="2" pos="5208" userDrawn="1">
          <p15:clr>
            <a:srgbClr val="A4A3A4"/>
          </p15:clr>
        </p15:guide>
        <p15:guide id="3" orient="horz" pos="6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206" y="72"/>
      </p:cViewPr>
      <p:guideLst>
        <p:guide orient="horz" pos="2424"/>
        <p:guide pos="5208"/>
        <p:guide orient="horz" pos="6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29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87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94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325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69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318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357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151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304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425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469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6A14F-2D5C-4682-9E06-A3556F28E880}" type="datetimeFigureOut">
              <a:rPr lang="en-US" smtClean="0"/>
              <a:t>8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98F71-0D43-48FB-95CF-67391EE97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60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9.emf"/><Relationship Id="rId4" Type="http://schemas.openxmlformats.org/officeDocument/2006/relationships/oleObject" Target="../embeddings/oleObject2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emf"/><Relationship Id="rId4" Type="http://schemas.openxmlformats.org/officeDocument/2006/relationships/oleObject" Target="../embeddings/oleObject5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224156" y="1142308"/>
            <a:ext cx="11072495" cy="2571586"/>
            <a:chOff x="71756" y="180283"/>
            <a:chExt cx="11072495" cy="257158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7576" b="4923"/>
            <a:stretch/>
          </p:blipFill>
          <p:spPr>
            <a:xfrm>
              <a:off x="199683" y="188870"/>
              <a:ext cx="2256409" cy="2286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9348" b="7077"/>
            <a:stretch/>
          </p:blipFill>
          <p:spPr>
            <a:xfrm>
              <a:off x="3094268" y="188870"/>
              <a:ext cx="2254681" cy="222885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8181" b="6462"/>
            <a:stretch/>
          </p:blipFill>
          <p:spPr>
            <a:xfrm>
              <a:off x="5981700" y="188870"/>
              <a:ext cx="2278478" cy="2286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/>
            <a:srcRect l="8741" b="6154"/>
            <a:stretch/>
          </p:blipFill>
          <p:spPr>
            <a:xfrm>
              <a:off x="8864355" y="180283"/>
              <a:ext cx="2279896" cy="232479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114425" y="247487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170744" y="120417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SSC-A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98815" y="247487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654487" y="1164795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H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052895" y="247487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5600700" y="120417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CD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004303" y="2468864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8483356" y="123661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4</a:t>
              </a: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>
              <a:off x="2525925" y="133187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>
              <a:off x="5535825" y="133187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8389769" y="133024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501156" y="4200525"/>
            <a:ext cx="1096694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1: Gating strategy for RA and HC PBMC derived CD4</a:t>
            </a:r>
            <a:r>
              <a:rPr lang="en-US" sz="1600" b="1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T cell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Representative flow cytometry plots depict the gating strategy for all RA and HC CD4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 cell based experiments. Lymphocyte population is gated first, and then the singlet population is gated. Subsequently, live cells are gated based on staining of dead cells using Zombie violet dye (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Biolegend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). The dual positive CD3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CD4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 cell population is eventually selected gated on the live cells and considered for further analysis of surface or intracellular protein markers.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1818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724090" y="611204"/>
            <a:ext cx="9767680" cy="3294358"/>
            <a:chOff x="724090" y="611204"/>
            <a:chExt cx="9767680" cy="3294358"/>
          </a:xfrm>
        </p:grpSpPr>
        <p:grpSp>
          <p:nvGrpSpPr>
            <p:cNvPr id="15" name="Group 14"/>
            <p:cNvGrpSpPr/>
            <p:nvPr/>
          </p:nvGrpSpPr>
          <p:grpSpPr>
            <a:xfrm>
              <a:off x="724090" y="798897"/>
              <a:ext cx="9767680" cy="3106665"/>
              <a:chOff x="724090" y="798897"/>
              <a:chExt cx="9767680" cy="3106665"/>
            </a:xfrm>
          </p:grpSpPr>
          <p:graphicFrame>
            <p:nvGraphicFramePr>
              <p:cNvPr id="2" name="Object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72082651"/>
                  </p:ext>
                </p:extLst>
              </p:nvPr>
            </p:nvGraphicFramePr>
            <p:xfrm>
              <a:off x="6878620" y="984034"/>
              <a:ext cx="3613150" cy="27130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" imgW="3613242" imgH="2712955" progId="Prism9.Document">
                      <p:embed/>
                    </p:oleObj>
                  </mc:Choice>
                  <mc:Fallback>
                    <p:oleObj name="Prism 9" r:id="rId2" imgW="3613242" imgH="2712955" progId="Prism9.Document">
                      <p:embed/>
                      <p:pic>
                        <p:nvPicPr>
                          <p:cNvPr id="0" name="Object 1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3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6878620" y="984034"/>
                            <a:ext cx="3613150" cy="2713037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3" name="Group 12"/>
              <p:cNvGrpSpPr/>
              <p:nvPr/>
            </p:nvGrpSpPr>
            <p:grpSpPr>
              <a:xfrm>
                <a:off x="724090" y="885536"/>
                <a:ext cx="2806378" cy="3020026"/>
                <a:chOff x="570023" y="1134772"/>
                <a:chExt cx="3104821" cy="3203915"/>
              </a:xfrm>
            </p:grpSpPr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7224" b="3405"/>
                <a:stretch/>
              </p:blipFill>
              <p:spPr>
                <a:xfrm>
                  <a:off x="847021" y="1134772"/>
                  <a:ext cx="2827823" cy="2898214"/>
                </a:xfrm>
                <a:prstGeom prst="rect">
                  <a:avLst/>
                </a:prstGeom>
              </p:spPr>
            </p:pic>
            <p:sp>
              <p:nvSpPr>
                <p:cNvPr id="4" name="TextBox 3"/>
                <p:cNvSpPr txBox="1"/>
                <p:nvPr/>
              </p:nvSpPr>
              <p:spPr>
                <a:xfrm>
                  <a:off x="847022" y="4061688"/>
                  <a:ext cx="9336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b="1" dirty="0"/>
                    <a:t>p-Akt1</a:t>
                  </a: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 rot="16200000">
                  <a:off x="241698" y="3427662"/>
                  <a:ext cx="9336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1200" b="1" dirty="0"/>
                    <a:t>SSC-A</a:t>
                  </a:r>
                </a:p>
              </p:txBody>
            </p:sp>
            <p:cxnSp>
              <p:nvCxnSpPr>
                <p:cNvPr id="9" name="Straight Arrow Connector 8"/>
                <p:cNvCxnSpPr/>
                <p:nvPr/>
              </p:nvCxnSpPr>
              <p:spPr>
                <a:xfrm>
                  <a:off x="764191" y="4034965"/>
                  <a:ext cx="1121363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Arrow Connector 10"/>
                <p:cNvCxnSpPr/>
                <p:nvPr/>
              </p:nvCxnSpPr>
              <p:spPr>
                <a:xfrm flipV="1">
                  <a:off x="868466" y="3205214"/>
                  <a:ext cx="0" cy="943651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5"/>
              <a:srcRect l="8235" b="4606"/>
              <a:stretch/>
            </p:blipFill>
            <p:spPr>
              <a:xfrm>
                <a:off x="3607469" y="798897"/>
                <a:ext cx="2671217" cy="2845564"/>
              </a:xfrm>
              <a:prstGeom prst="rect">
                <a:avLst/>
              </a:prstGeom>
            </p:spPr>
          </p:pic>
        </p:grpSp>
        <p:sp>
          <p:nvSpPr>
            <p:cNvPr id="16" name="TextBox 15"/>
            <p:cNvSpPr txBox="1"/>
            <p:nvPr/>
          </p:nvSpPr>
          <p:spPr>
            <a:xfrm>
              <a:off x="2127183" y="611204"/>
              <a:ext cx="1039529" cy="375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HC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878333" y="628854"/>
              <a:ext cx="1039529" cy="375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RA</a:t>
              </a: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434390" y="4030756"/>
            <a:ext cx="109669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0: Analysis of p-Akt1 expression in CD4</a:t>
            </a:r>
            <a:r>
              <a:rPr 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of RA as compared with HC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and graphical plots show differential p-Akt1 expression in RA (n=5) and HC (n=4)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Statistical analysis is based on 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n-Whitney U Test to compare between the two groups where p&lt;0.05 was considered statistically significant (*)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298277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3376" y="5387918"/>
            <a:ext cx="109669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1: Biexponential plots representing T helper subsets expressing RANKL in Healthy Controls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show the insignificant RANKL expression in various compartments of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Healthy controls and the absence of dual CXCR3-CCR6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in HC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Group 30"/>
          <p:cNvGrpSpPr/>
          <p:nvPr/>
        </p:nvGrpSpPr>
        <p:grpSpPr>
          <a:xfrm>
            <a:off x="55597" y="2751444"/>
            <a:ext cx="2334569" cy="2307558"/>
            <a:chOff x="5036802" y="404846"/>
            <a:chExt cx="2334569" cy="2307558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2"/>
            <a:srcRect l="6666" b="3668"/>
            <a:stretch/>
          </p:blipFill>
          <p:spPr>
            <a:xfrm>
              <a:off x="5215803" y="404846"/>
              <a:ext cx="2155568" cy="2149622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5496023" y="2529281"/>
              <a:ext cx="724939" cy="183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CXCR3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4774308" y="1869231"/>
              <a:ext cx="711556" cy="186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CCR6</a:t>
              </a:r>
            </a:p>
          </p:txBody>
        </p:sp>
        <p:cxnSp>
          <p:nvCxnSpPr>
            <p:cNvPr id="25" name="Straight Arrow Connector 24"/>
            <p:cNvCxnSpPr/>
            <p:nvPr/>
          </p:nvCxnSpPr>
          <p:spPr>
            <a:xfrm>
              <a:off x="5207333" y="2516686"/>
              <a:ext cx="885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 flipV="1">
              <a:off x="5239409" y="1606736"/>
              <a:ext cx="0" cy="94773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/>
          <p:cNvGrpSpPr/>
          <p:nvPr/>
        </p:nvGrpSpPr>
        <p:grpSpPr>
          <a:xfrm>
            <a:off x="150993" y="207653"/>
            <a:ext cx="9700100" cy="2323042"/>
            <a:chOff x="136809" y="445215"/>
            <a:chExt cx="9700100" cy="2323042"/>
          </a:xfrm>
        </p:grpSpPr>
        <p:sp>
          <p:nvSpPr>
            <p:cNvPr id="20" name="TextBox 19"/>
            <p:cNvSpPr txBox="1"/>
            <p:nvPr/>
          </p:nvSpPr>
          <p:spPr>
            <a:xfrm rot="16200000">
              <a:off x="-125685" y="1928490"/>
              <a:ext cx="711556" cy="1865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RANKL</a:t>
              </a:r>
            </a:p>
          </p:txBody>
        </p:sp>
        <p:grpSp>
          <p:nvGrpSpPr>
            <p:cNvPr id="32" name="Group 31"/>
            <p:cNvGrpSpPr/>
            <p:nvPr/>
          </p:nvGrpSpPr>
          <p:grpSpPr>
            <a:xfrm>
              <a:off x="323376" y="445215"/>
              <a:ext cx="9513533" cy="2323042"/>
              <a:chOff x="226006" y="404847"/>
              <a:chExt cx="9513533" cy="2323042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3"/>
              <a:srcRect l="7989" b="3905"/>
              <a:stretch/>
            </p:blipFill>
            <p:spPr>
              <a:xfrm>
                <a:off x="267446" y="404847"/>
                <a:ext cx="2142738" cy="2162214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4"/>
              <a:srcRect l="7438" b="5024"/>
              <a:stretch/>
            </p:blipFill>
            <p:spPr>
              <a:xfrm>
                <a:off x="2717382" y="404847"/>
                <a:ext cx="2155570" cy="2137027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453752" y="2541874"/>
                <a:ext cx="724939" cy="183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CR6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2300596" y="1951092"/>
                <a:ext cx="711556" cy="1865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RANKL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853777" y="2544766"/>
                <a:ext cx="724939" cy="183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XCR3</a:t>
                </a:r>
              </a:p>
            </p:txBody>
          </p:sp>
          <p:cxnSp>
            <p:nvCxnSpPr>
              <p:cNvPr id="27" name="Straight Arrow Connector 26"/>
              <p:cNvCxnSpPr/>
              <p:nvPr/>
            </p:nvCxnSpPr>
            <p:spPr>
              <a:xfrm>
                <a:off x="2705444" y="2535578"/>
                <a:ext cx="88532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V="1">
                <a:off x="2737520" y="1625627"/>
                <a:ext cx="0" cy="9477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Arrow Connector 28"/>
              <p:cNvCxnSpPr/>
              <p:nvPr/>
            </p:nvCxnSpPr>
            <p:spPr>
              <a:xfrm>
                <a:off x="226006" y="2529281"/>
                <a:ext cx="88532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Arrow Connector 29"/>
              <p:cNvCxnSpPr/>
              <p:nvPr/>
            </p:nvCxnSpPr>
            <p:spPr>
              <a:xfrm flipV="1">
                <a:off x="258082" y="1619330"/>
                <a:ext cx="0" cy="9477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" name="Group 4"/>
              <p:cNvGrpSpPr/>
              <p:nvPr/>
            </p:nvGrpSpPr>
            <p:grpSpPr>
              <a:xfrm>
                <a:off x="5051291" y="417177"/>
                <a:ext cx="4688248" cy="2310712"/>
                <a:chOff x="3826880" y="3548221"/>
                <a:chExt cx="6418985" cy="3145425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7488" b="3514"/>
                <a:stretch/>
              </p:blipFill>
              <p:spPr>
                <a:xfrm>
                  <a:off x="4078229" y="3548221"/>
                  <a:ext cx="2819742" cy="2894915"/>
                </a:xfrm>
                <a:prstGeom prst="rect">
                  <a:avLst/>
                </a:prstGeom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6905" b="4926"/>
                <a:stretch/>
              </p:blipFill>
              <p:spPr>
                <a:xfrm>
                  <a:off x="7408333" y="3548221"/>
                  <a:ext cx="2837532" cy="2852579"/>
                </a:xfrm>
                <a:prstGeom prst="rect">
                  <a:avLst/>
                </a:prstGeom>
              </p:spPr>
            </p:pic>
            <p:cxnSp>
              <p:nvCxnSpPr>
                <p:cNvPr id="8" name="Straight Arrow Connector 7"/>
                <p:cNvCxnSpPr/>
                <p:nvPr/>
              </p:nvCxnSpPr>
              <p:spPr>
                <a:xfrm>
                  <a:off x="3949392" y="6443136"/>
                  <a:ext cx="1168399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Arrow Connector 8"/>
                <p:cNvCxnSpPr/>
                <p:nvPr/>
              </p:nvCxnSpPr>
              <p:spPr>
                <a:xfrm flipV="1">
                  <a:off x="4073101" y="5329713"/>
                  <a:ext cx="0" cy="127428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 rot="16200000">
                  <a:off x="3471624" y="5841659"/>
                  <a:ext cx="9567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RANKL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4154965" y="6447426"/>
                  <a:ext cx="956734" cy="246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CXCR5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7708900" y="6400803"/>
                  <a:ext cx="9567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CCR4</a:t>
                  </a:r>
                </a:p>
              </p:txBody>
            </p:sp>
            <p:cxnSp>
              <p:nvCxnSpPr>
                <p:cNvPr id="13" name="Straight Arrow Connector 12"/>
                <p:cNvCxnSpPr/>
                <p:nvPr/>
              </p:nvCxnSpPr>
              <p:spPr>
                <a:xfrm>
                  <a:off x="7289799" y="6400800"/>
                  <a:ext cx="1168399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/>
                <p:cNvSpPr txBox="1"/>
                <p:nvPr/>
              </p:nvSpPr>
              <p:spPr>
                <a:xfrm rot="16200000">
                  <a:off x="6816955" y="5570037"/>
                  <a:ext cx="95673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RANKL</a:t>
                  </a:r>
                </a:p>
              </p:txBody>
            </p:sp>
            <p:cxnSp>
              <p:nvCxnSpPr>
                <p:cNvPr id="15" name="Straight Arrow Connector 14"/>
                <p:cNvCxnSpPr/>
                <p:nvPr/>
              </p:nvCxnSpPr>
              <p:spPr>
                <a:xfrm flipV="1">
                  <a:off x="7418433" y="5329713"/>
                  <a:ext cx="0" cy="1274289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3797257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/>
        </p:nvGrpSpPr>
        <p:grpSpPr>
          <a:xfrm>
            <a:off x="480625" y="261615"/>
            <a:ext cx="8457812" cy="2562999"/>
            <a:chOff x="480625" y="261615"/>
            <a:chExt cx="8457812" cy="2562999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2"/>
            <a:srcRect l="6394" b="4453"/>
            <a:stretch/>
          </p:blipFill>
          <p:spPr>
            <a:xfrm>
              <a:off x="619125" y="261615"/>
              <a:ext cx="2171290" cy="2286000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3"/>
            <a:srcRect l="9481" b="4286"/>
            <a:stretch/>
          </p:blipFill>
          <p:spPr>
            <a:xfrm>
              <a:off x="3619500" y="309240"/>
              <a:ext cx="2244298" cy="22860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4"/>
            <a:srcRect l="8125" b="4445"/>
            <a:stretch/>
          </p:blipFill>
          <p:spPr>
            <a:xfrm>
              <a:off x="6705600" y="309240"/>
              <a:ext cx="2232837" cy="22860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1590675" y="2547615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238125" y="1297232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SSC-A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781550" y="2547615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3168838" y="1256912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H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743825" y="249555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6324213" y="1256911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CD</a:t>
              </a:r>
            </a:p>
          </p:txBody>
        </p:sp>
        <p:cxnSp>
          <p:nvCxnSpPr>
            <p:cNvPr id="39" name="Straight Arrow Connector 38"/>
            <p:cNvCxnSpPr/>
            <p:nvPr/>
          </p:nvCxnSpPr>
          <p:spPr>
            <a:xfrm>
              <a:off x="3075251" y="148427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6096000" y="148264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619125" y="3019024"/>
            <a:ext cx="109669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2: Gating strategy for </a:t>
            </a:r>
            <a:r>
              <a:rPr lang="en-US" sz="1600" b="1" i="1" dirty="0">
                <a:latin typeface="Times New Roman" pitchFamily="18" charset="0"/>
                <a:cs typeface="Times New Roman" pitchFamily="18" charset="0"/>
              </a:rPr>
              <a:t>ex vivo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differentiated CD4</a:t>
            </a:r>
            <a:r>
              <a:rPr lang="en-US" sz="1600" b="1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T cell experiment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For analysis of surface and intracellular protein markers in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ex vivo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differentiated human Th17 cells, the cells were primarily gated on the lymphocyte population, further gating on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singlr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population. Subsequently, the cells were gated on the live cells based on staining of dead cells by the Zombie violet dye (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Biolegend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) and then analyzed for the specific surface and intracellular markers of Th17 cells.  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04217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166299" y="0"/>
            <a:ext cx="10635050" cy="3139262"/>
            <a:chOff x="166299" y="0"/>
            <a:chExt cx="10635050" cy="313926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7812" b="4603"/>
            <a:stretch/>
          </p:blipFill>
          <p:spPr>
            <a:xfrm>
              <a:off x="314324" y="0"/>
              <a:ext cx="2809875" cy="2862263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9633" b="4603"/>
            <a:stretch/>
          </p:blipFill>
          <p:spPr>
            <a:xfrm>
              <a:off x="4248150" y="0"/>
              <a:ext cx="2814637" cy="286226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/>
            <a:srcRect l="9218" b="3968"/>
            <a:stretch/>
          </p:blipFill>
          <p:spPr>
            <a:xfrm>
              <a:off x="8034337" y="0"/>
              <a:ext cx="2767012" cy="2881313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428750" y="2862263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76201" y="107082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SSC-A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579268" y="2772221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709987" y="1218812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H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9277350" y="275388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4</a:t>
              </a: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>
              <a:off x="3465776" y="148427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>
              <a:off x="7466276" y="148427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 23"/>
          <p:cNvGrpSpPr/>
          <p:nvPr/>
        </p:nvGrpSpPr>
        <p:grpSpPr>
          <a:xfrm>
            <a:off x="166298" y="3205163"/>
            <a:ext cx="10625526" cy="3073361"/>
            <a:chOff x="166298" y="3205163"/>
            <a:chExt cx="10625526" cy="307336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/>
            <a:srcRect l="8075" b="3780"/>
            <a:stretch/>
          </p:blipFill>
          <p:spPr>
            <a:xfrm>
              <a:off x="304799" y="3205163"/>
              <a:ext cx="2819400" cy="290988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/>
            <a:srcRect l="8549" t="-1" b="4792"/>
            <a:stretch/>
          </p:blipFill>
          <p:spPr>
            <a:xfrm>
              <a:off x="4210050" y="3205163"/>
              <a:ext cx="2852737" cy="283845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7"/>
            <a:srcRect l="10625" b="4921"/>
            <a:stretch/>
          </p:blipFill>
          <p:spPr>
            <a:xfrm>
              <a:off x="8067676" y="3205164"/>
              <a:ext cx="2724148" cy="2852736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-76202" y="452160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SSC-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333499" y="6001525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19724" y="598325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3732200" y="4381112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H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9248775" y="599354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4</a:t>
              </a:r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3399101" y="466562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>
            <a:xfrm>
              <a:off x="7312552" y="4665620"/>
              <a:ext cx="3360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TextBox 24"/>
          <p:cNvSpPr txBox="1"/>
          <p:nvPr/>
        </p:nvSpPr>
        <p:spPr>
          <a:xfrm>
            <a:off x="476796" y="6271214"/>
            <a:ext cx="109669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3: CD4</a:t>
            </a:r>
            <a:r>
              <a:rPr lang="en-US" sz="1600" b="1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T cell purity validated for </a:t>
            </a:r>
            <a:r>
              <a:rPr lang="en-US" sz="1600" b="1" i="1" dirty="0">
                <a:latin typeface="Times New Roman" pitchFamily="18" charset="0"/>
                <a:cs typeface="Times New Roman" pitchFamily="18" charset="0"/>
              </a:rPr>
              <a:t>ex vivo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experiment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Representative flow cytometry plot shows the purity of CD4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 cells derived from PBMC of healthy controls confirmed prior to initiation of Th17 polarization.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0932668" y="218728"/>
            <a:ext cx="1085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efore isolation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932668" y="3464202"/>
            <a:ext cx="1085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fter isolation</a:t>
            </a:r>
          </a:p>
        </p:txBody>
      </p:sp>
    </p:spTree>
    <p:extLst>
      <p:ext uri="{BB962C8B-B14F-4D97-AF65-F5344CB8AC3E}">
        <p14:creationId xmlns:p14="http://schemas.microsoft.com/office/powerpoint/2010/main" val="16148854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736699" y="223838"/>
            <a:ext cx="6950084" cy="5846564"/>
            <a:chOff x="736699" y="223838"/>
            <a:chExt cx="6950084" cy="5846564"/>
          </a:xfrm>
        </p:grpSpPr>
        <p:grpSp>
          <p:nvGrpSpPr>
            <p:cNvPr id="20" name="Group 19"/>
            <p:cNvGrpSpPr/>
            <p:nvPr/>
          </p:nvGrpSpPr>
          <p:grpSpPr>
            <a:xfrm>
              <a:off x="736699" y="233363"/>
              <a:ext cx="2866797" cy="5837039"/>
              <a:chOff x="736699" y="233363"/>
              <a:chExt cx="2866797" cy="5837039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/>
              <a:srcRect l="8181" b="5692"/>
              <a:stretch/>
            </p:blipFill>
            <p:spPr>
              <a:xfrm>
                <a:off x="981075" y="2920695"/>
                <a:ext cx="2622421" cy="2652713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3"/>
              <a:srcRect l="8485" b="4462"/>
              <a:stretch/>
            </p:blipFill>
            <p:spPr>
              <a:xfrm>
                <a:off x="981075" y="233363"/>
                <a:ext cx="2579167" cy="2651760"/>
              </a:xfrm>
              <a:prstGeom prst="rect">
                <a:avLst/>
              </a:prstGeom>
            </p:spPr>
          </p:pic>
          <p:grpSp>
            <p:nvGrpSpPr>
              <p:cNvPr id="14" name="Group 13"/>
              <p:cNvGrpSpPr/>
              <p:nvPr/>
            </p:nvGrpSpPr>
            <p:grpSpPr>
              <a:xfrm>
                <a:off x="736699" y="4442698"/>
                <a:ext cx="1644551" cy="1627704"/>
                <a:chOff x="736699" y="4442698"/>
                <a:chExt cx="1644551" cy="1627704"/>
              </a:xfrm>
            </p:grpSpPr>
            <p:cxnSp>
              <p:nvCxnSpPr>
                <p:cNvPr id="6" name="Straight Arrow Connector 5"/>
                <p:cNvCxnSpPr/>
                <p:nvPr/>
              </p:nvCxnSpPr>
              <p:spPr>
                <a:xfrm flipV="1">
                  <a:off x="981075" y="5753101"/>
                  <a:ext cx="1400175" cy="9524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9"/>
                <p:cNvSpPr txBox="1"/>
                <p:nvPr/>
              </p:nvSpPr>
              <p:spPr>
                <a:xfrm>
                  <a:off x="1114425" y="5762625"/>
                  <a:ext cx="126682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IL-21R</a:t>
                  </a:r>
                </a:p>
              </p:txBody>
            </p:sp>
            <p:cxnSp>
              <p:nvCxnSpPr>
                <p:cNvPr id="11" name="Straight Arrow Connector 10"/>
                <p:cNvCxnSpPr/>
                <p:nvPr/>
              </p:nvCxnSpPr>
              <p:spPr>
                <a:xfrm flipH="1" flipV="1">
                  <a:off x="971550" y="4591050"/>
                  <a:ext cx="19050" cy="1190625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/>
                <p:cNvSpPr txBox="1"/>
                <p:nvPr/>
              </p:nvSpPr>
              <p:spPr>
                <a:xfrm rot="16200000">
                  <a:off x="257175" y="4922222"/>
                  <a:ext cx="126682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SSC-A</a:t>
                  </a:r>
                </a:p>
              </p:txBody>
            </p:sp>
          </p:grpSp>
        </p:grpSp>
        <p:grpSp>
          <p:nvGrpSpPr>
            <p:cNvPr id="21" name="Group 20"/>
            <p:cNvGrpSpPr/>
            <p:nvPr/>
          </p:nvGrpSpPr>
          <p:grpSpPr>
            <a:xfrm>
              <a:off x="4011582" y="223838"/>
              <a:ext cx="2902568" cy="5723453"/>
              <a:chOff x="4011582" y="223838"/>
              <a:chExt cx="2902568" cy="572345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4"/>
              <a:srcRect l="8485" b="5077"/>
              <a:stretch/>
            </p:blipFill>
            <p:spPr>
              <a:xfrm>
                <a:off x="4305300" y="2923223"/>
                <a:ext cx="2595888" cy="265176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5"/>
              <a:srcRect l="7879" b="4923"/>
              <a:stretch/>
            </p:blipFill>
            <p:spPr>
              <a:xfrm>
                <a:off x="4305300" y="223838"/>
                <a:ext cx="2608850" cy="2651760"/>
              </a:xfrm>
              <a:prstGeom prst="rect">
                <a:avLst/>
              </a:prstGeom>
            </p:spPr>
          </p:pic>
          <p:grpSp>
            <p:nvGrpSpPr>
              <p:cNvPr id="15" name="Group 14"/>
              <p:cNvGrpSpPr/>
              <p:nvPr/>
            </p:nvGrpSpPr>
            <p:grpSpPr>
              <a:xfrm>
                <a:off x="4011582" y="4319587"/>
                <a:ext cx="1644551" cy="1627704"/>
                <a:chOff x="736699" y="4442698"/>
                <a:chExt cx="1644551" cy="1627704"/>
              </a:xfrm>
            </p:grpSpPr>
            <p:cxnSp>
              <p:nvCxnSpPr>
                <p:cNvPr id="16" name="Straight Arrow Connector 15"/>
                <p:cNvCxnSpPr/>
                <p:nvPr/>
              </p:nvCxnSpPr>
              <p:spPr>
                <a:xfrm flipV="1">
                  <a:off x="981075" y="5753101"/>
                  <a:ext cx="1400175" cy="9524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6"/>
                <p:cNvSpPr txBox="1"/>
                <p:nvPr/>
              </p:nvSpPr>
              <p:spPr>
                <a:xfrm>
                  <a:off x="1114425" y="5762625"/>
                  <a:ext cx="126682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IL-23R</a:t>
                  </a:r>
                </a:p>
              </p:txBody>
            </p:sp>
            <p:cxnSp>
              <p:nvCxnSpPr>
                <p:cNvPr id="18" name="Straight Arrow Connector 17"/>
                <p:cNvCxnSpPr/>
                <p:nvPr/>
              </p:nvCxnSpPr>
              <p:spPr>
                <a:xfrm flipH="1" flipV="1">
                  <a:off x="971550" y="4591050"/>
                  <a:ext cx="19050" cy="1190625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257175" y="4922222"/>
                  <a:ext cx="126682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/>
                    <a:t>SSC-A</a:t>
                  </a:r>
                </a:p>
              </p:txBody>
            </p:sp>
          </p:grpSp>
        </p:grpSp>
        <p:sp>
          <p:nvSpPr>
            <p:cNvPr id="22" name="TextBox 21"/>
            <p:cNvSpPr txBox="1"/>
            <p:nvPr/>
          </p:nvSpPr>
          <p:spPr>
            <a:xfrm>
              <a:off x="6948813" y="371475"/>
              <a:ext cx="7239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C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962883" y="3067050"/>
              <a:ext cx="7239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RA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476796" y="6194214"/>
            <a:ext cx="109669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4: Expression of IL-21R and IL-23R in HC and RA CD4</a:t>
            </a:r>
            <a:r>
              <a:rPr lang="en-US" sz="1600" b="1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T cells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Surface expression of IL-21 and IL-23 Receptors in RA and HC CD4</a:t>
            </a:r>
            <a:r>
              <a:rPr lang="en-US" sz="160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 cells are represented as flow cytometry plots.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2550272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2665473"/>
              </p:ext>
            </p:extLst>
          </p:nvPr>
        </p:nvGraphicFramePr>
        <p:xfrm>
          <a:off x="877371" y="809624"/>
          <a:ext cx="3516995" cy="2357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80102" imgH="2600260" progId="Prism9.Document">
                  <p:embed/>
                </p:oleObj>
              </mc:Choice>
              <mc:Fallback>
                <p:oleObj name="Prism 9" r:id="rId2" imgW="3880102" imgH="2600260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77371" y="809624"/>
                        <a:ext cx="3516995" cy="235713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0800776"/>
              </p:ext>
            </p:extLst>
          </p:nvPr>
        </p:nvGraphicFramePr>
        <p:xfrm>
          <a:off x="4088465" y="799692"/>
          <a:ext cx="3528989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835805" imgH="2543733" progId="Prism9.Document">
                  <p:embed/>
                </p:oleObj>
              </mc:Choice>
              <mc:Fallback>
                <p:oleObj name="Prism 9" r:id="rId4" imgW="3835805" imgH="2543733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88465" y="799692"/>
                        <a:ext cx="3528989" cy="23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2542356"/>
              </p:ext>
            </p:extLst>
          </p:nvPr>
        </p:nvGraphicFramePr>
        <p:xfrm>
          <a:off x="7303307" y="783816"/>
          <a:ext cx="3485473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835805" imgH="2574337" progId="Prism9.Document">
                  <p:embed/>
                </p:oleObj>
              </mc:Choice>
              <mc:Fallback>
                <p:oleObj name="Prism 9" r:id="rId6" imgW="3835805" imgH="2574337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303307" y="783816"/>
                        <a:ext cx="3485473" cy="234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61292" y="3663434"/>
            <a:ext cx="114681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: Graphical representation of %GMCSF</a:t>
            </a:r>
            <a:r>
              <a:rPr 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RA with inhibition of IL-21, IL-23 and both in combination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cking of cytokines, IL-21 and or IL-23 did not show any effect on GMCSF expression in RA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as analyzed by paired T test and represented as Mean± SD. 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428384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1344674"/>
              </p:ext>
            </p:extLst>
          </p:nvPr>
        </p:nvGraphicFramePr>
        <p:xfrm>
          <a:off x="4815609" y="566160"/>
          <a:ext cx="4038600" cy="2713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038562" imgH="2712955" progId="Prism9.Document">
                  <p:embed/>
                </p:oleObj>
              </mc:Choice>
              <mc:Fallback>
                <p:oleObj name="Prism 9" r:id="rId2" imgW="4038562" imgH="27129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15609" y="566160"/>
                        <a:ext cx="4038600" cy="2713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0773621"/>
              </p:ext>
            </p:extLst>
          </p:nvPr>
        </p:nvGraphicFramePr>
        <p:xfrm>
          <a:off x="770082" y="529215"/>
          <a:ext cx="4038600" cy="2713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038562" imgH="2712955" progId="Prism9.Document">
                  <p:embed/>
                </p:oleObj>
              </mc:Choice>
              <mc:Fallback>
                <p:oleObj name="Prism 9" r:id="rId4" imgW="4038562" imgH="2712955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0082" y="529215"/>
                        <a:ext cx="4038600" cy="27130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05200" y="3478768"/>
            <a:ext cx="109669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: </a:t>
            </a:r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FI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RANKL expression in RA and HC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ical representation of RANKL expression in RA and HC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as interpreted by integrated MFI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F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statistically analyzed by Mann-Whitney test, represented as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03148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 rot="16200000">
            <a:off x="-114300" y="1221032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SC-A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266699" y="290510"/>
            <a:ext cx="10948757" cy="2562999"/>
            <a:chOff x="266699" y="290510"/>
            <a:chExt cx="10948757" cy="256299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7812" b="3333"/>
            <a:stretch/>
          </p:blipFill>
          <p:spPr>
            <a:xfrm>
              <a:off x="266699" y="290510"/>
              <a:ext cx="2214680" cy="22860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9327" b="4921"/>
            <a:stretch/>
          </p:blipFill>
          <p:spPr>
            <a:xfrm>
              <a:off x="3148011" y="290510"/>
              <a:ext cx="2263100" cy="22860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/>
            <a:srcRect l="8594" b="3968"/>
            <a:stretch/>
          </p:blipFill>
          <p:spPr>
            <a:xfrm>
              <a:off x="6148385" y="290511"/>
              <a:ext cx="2210428" cy="22860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/>
            <a:srcRect l="8125" b="5873"/>
            <a:stretch/>
          </p:blipFill>
          <p:spPr>
            <a:xfrm>
              <a:off x="8948733" y="290511"/>
              <a:ext cx="2266723" cy="2286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238250" y="257651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26821" y="257650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671373" y="1295010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H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5767385" y="1295009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DCD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141029" y="257650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-A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082094" y="257650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3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8567733" y="1295008"/>
              <a:ext cx="762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CD4</a:t>
              </a:r>
            </a:p>
          </p:txBody>
        </p:sp>
        <p:cxnSp>
          <p:nvCxnSpPr>
            <p:cNvPr id="17" name="Straight Arrow Connector 16"/>
            <p:cNvCxnSpPr>
              <a:endCxn id="11" idx="0"/>
            </p:cNvCxnSpPr>
            <p:nvPr/>
          </p:nvCxnSpPr>
          <p:spPr>
            <a:xfrm>
              <a:off x="2733675" y="1433507"/>
              <a:ext cx="180199" cy="3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5730181" y="1457315"/>
              <a:ext cx="180199" cy="3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8506136" y="1433507"/>
              <a:ext cx="180199" cy="3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0"/>
          <p:cNvSpPr txBox="1"/>
          <p:nvPr/>
        </p:nvSpPr>
        <p:spPr>
          <a:xfrm>
            <a:off x="405200" y="3478768"/>
            <a:ext cx="109669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: Analysis of T cells in OA SF derived cells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shows the absence of any CD3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 in synovial fluid derived from patients of Osteoarthritis. 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2697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5194" y="1028700"/>
            <a:ext cx="10697174" cy="2404535"/>
            <a:chOff x="885228" y="2351328"/>
            <a:chExt cx="10697174" cy="2404535"/>
          </a:xfrm>
        </p:grpSpPr>
        <p:grpSp>
          <p:nvGrpSpPr>
            <p:cNvPr id="3" name="Group 2"/>
            <p:cNvGrpSpPr/>
            <p:nvPr/>
          </p:nvGrpSpPr>
          <p:grpSpPr>
            <a:xfrm>
              <a:off x="1058332" y="2351328"/>
              <a:ext cx="10524070" cy="2404535"/>
              <a:chOff x="1058332" y="607192"/>
              <a:chExt cx="10524070" cy="2404535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/>
              <a:srcRect l="10196" b="25888"/>
              <a:stretch/>
            </p:blipFill>
            <p:spPr>
              <a:xfrm>
                <a:off x="1058332" y="637825"/>
                <a:ext cx="1955801" cy="2023659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/>
              <a:srcRect l="8879" b="24127"/>
              <a:stretch/>
            </p:blipFill>
            <p:spPr>
              <a:xfrm>
                <a:off x="3014133" y="622829"/>
                <a:ext cx="2014844" cy="2103438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4"/>
              <a:srcRect l="8039" b="25118"/>
              <a:stretch/>
            </p:blipFill>
            <p:spPr>
              <a:xfrm>
                <a:off x="9430394" y="607192"/>
                <a:ext cx="2152008" cy="2197037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5"/>
              <a:srcRect l="8736" b="25549"/>
              <a:stretch/>
            </p:blipFill>
            <p:spPr>
              <a:xfrm>
                <a:off x="5063581" y="622829"/>
                <a:ext cx="2122763" cy="2171170"/>
              </a:xfrm>
              <a:prstGeom prst="rect">
                <a:avLst/>
              </a:prstGeom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6"/>
              <a:srcRect l="10461" b="24511"/>
              <a:stretch/>
            </p:blipFill>
            <p:spPr>
              <a:xfrm>
                <a:off x="7323667" y="622829"/>
                <a:ext cx="2089792" cy="2208983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1801907" y="2596229"/>
                <a:ext cx="700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IFN-</a:t>
                </a:r>
                <a:r>
                  <a:rPr lang="el-GR" sz="1200" b="1" dirty="0"/>
                  <a:t>γ</a:t>
                </a:r>
                <a:endParaRPr lang="en-US" sz="1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851355" y="2692398"/>
                <a:ext cx="700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IL-17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096000" y="2734728"/>
                <a:ext cx="700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NF-</a:t>
                </a:r>
                <a:r>
                  <a:rPr lang="el-GR" sz="1200" b="1" dirty="0"/>
                  <a:t>α</a:t>
                </a:r>
                <a:endParaRPr lang="en-US" sz="12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8218763" y="2734728"/>
                <a:ext cx="700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MCSF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0341526" y="2734728"/>
                <a:ext cx="7008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IL-10</a:t>
                </a: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 rot="16200000">
              <a:off x="673307" y="3332956"/>
              <a:ext cx="7008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SSC-A</a:t>
              </a:r>
            </a:p>
          </p:txBody>
        </p:sp>
        <p:cxnSp>
          <p:nvCxnSpPr>
            <p:cNvPr id="5" name="Straight Arrow Connector 4"/>
            <p:cNvCxnSpPr/>
            <p:nvPr/>
          </p:nvCxnSpPr>
          <p:spPr>
            <a:xfrm flipV="1">
              <a:off x="1023728" y="3019434"/>
              <a:ext cx="0" cy="3048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422915" y="3710226"/>
            <a:ext cx="109669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8: Expression of inflammatory and anti-inflammatory cytokines in RA synovial fluid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ow cytometry plots show insignificant expression of IFN-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, IL-17, TNF-</a:t>
            </a:r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α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and IL-10 and limited expression of GMCSF in RA synovial CD4</a:t>
            </a:r>
            <a:r>
              <a:rPr lang="en-IN" sz="1600" baseline="30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+</a:t>
            </a:r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 T cells (n=6)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31491517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576261" y="283035"/>
            <a:ext cx="9946235" cy="4908880"/>
            <a:chOff x="576261" y="283035"/>
            <a:chExt cx="9946235" cy="4908880"/>
          </a:xfrm>
        </p:grpSpPr>
        <p:grpSp>
          <p:nvGrpSpPr>
            <p:cNvPr id="24" name="Group 23"/>
            <p:cNvGrpSpPr/>
            <p:nvPr/>
          </p:nvGrpSpPr>
          <p:grpSpPr>
            <a:xfrm>
              <a:off x="629773" y="283035"/>
              <a:ext cx="9800998" cy="2091070"/>
              <a:chOff x="629773" y="283035"/>
              <a:chExt cx="9800998" cy="2091070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629773" y="387096"/>
                <a:ext cx="9800998" cy="1987009"/>
                <a:chOff x="86848" y="196596"/>
                <a:chExt cx="9800998" cy="1987009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869" b="2273"/>
                <a:stretch/>
              </p:blipFill>
              <p:spPr>
                <a:xfrm>
                  <a:off x="86848" y="264317"/>
                  <a:ext cx="1818152" cy="1919288"/>
                </a:xfrm>
                <a:prstGeom prst="rect">
                  <a:avLst/>
                </a:prstGeom>
              </p:spPr>
            </p:pic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9568" b="5080"/>
                <a:stretch/>
              </p:blipFill>
              <p:spPr>
                <a:xfrm>
                  <a:off x="2047875" y="245267"/>
                  <a:ext cx="1838325" cy="1875970"/>
                </a:xfrm>
                <a:prstGeom prst="rect">
                  <a:avLst/>
                </a:prstGeom>
              </p:spPr>
            </p:pic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1420" b="5079"/>
                <a:stretch/>
              </p:blipFill>
              <p:spPr>
                <a:xfrm>
                  <a:off x="4029075" y="226217"/>
                  <a:ext cx="1843171" cy="1920240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0185" b="6666"/>
                <a:stretch/>
              </p:blipFill>
              <p:spPr>
                <a:xfrm>
                  <a:off x="6010276" y="196596"/>
                  <a:ext cx="1905000" cy="1924639"/>
                </a:xfrm>
                <a:prstGeom prst="rect">
                  <a:avLst/>
                </a:prstGeom>
              </p:spPr>
            </p:pic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0802" b="3968"/>
                <a:stretch/>
              </p:blipFill>
              <p:spPr>
                <a:xfrm>
                  <a:off x="8053306" y="228004"/>
                  <a:ext cx="1834540" cy="1920240"/>
                </a:xfrm>
                <a:prstGeom prst="rect">
                  <a:avLst/>
                </a:prstGeom>
              </p:spPr>
            </p:pic>
          </p:grpSp>
          <p:sp>
            <p:nvSpPr>
              <p:cNvPr id="14" name="TextBox 13"/>
              <p:cNvSpPr txBox="1"/>
              <p:nvPr/>
            </p:nvSpPr>
            <p:spPr>
              <a:xfrm>
                <a:off x="1476375" y="312656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0’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460133" y="312656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05’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474082" y="292560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10’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457840" y="283035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15’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422968" y="292560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30’</a:t>
                </a:r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576261" y="2713050"/>
              <a:ext cx="9946235" cy="2139684"/>
              <a:chOff x="576261" y="2713050"/>
              <a:chExt cx="9946235" cy="2139684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576261" y="2817804"/>
                <a:ext cx="9946235" cy="2034930"/>
                <a:chOff x="100012" y="2166678"/>
                <a:chExt cx="9794669" cy="1876431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10185" b="5080"/>
                <a:stretch/>
              </p:blipFill>
              <p:spPr>
                <a:xfrm>
                  <a:off x="100012" y="2183605"/>
                  <a:ext cx="1809750" cy="1859504"/>
                </a:xfrm>
                <a:prstGeom prst="rect">
                  <a:avLst/>
                </a:prstGeom>
              </p:spPr>
            </p:pic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6875" b="5714"/>
                <a:stretch/>
              </p:blipFill>
              <p:spPr>
                <a:xfrm>
                  <a:off x="2031840" y="2176207"/>
                  <a:ext cx="1834955" cy="1828800"/>
                </a:xfrm>
                <a:prstGeom prst="rect">
                  <a:avLst/>
                </a:prstGeom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10000" b="6350"/>
                <a:stretch/>
              </p:blipFill>
              <p:spPr>
                <a:xfrm>
                  <a:off x="4027977" y="2166678"/>
                  <a:ext cx="1785402" cy="1828800"/>
                </a:xfrm>
                <a:prstGeom prst="rect">
                  <a:avLst/>
                </a:prstGeom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8333" b="4762"/>
                <a:stretch/>
              </p:blipFill>
              <p:spPr>
                <a:xfrm>
                  <a:off x="5991064" y="2193525"/>
                  <a:ext cx="1924212" cy="1828800"/>
                </a:xfrm>
                <a:prstGeom prst="rect">
                  <a:avLst/>
                </a:prstGeom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10000" b="5397"/>
                <a:stretch/>
              </p:blipFill>
              <p:spPr>
                <a:xfrm>
                  <a:off x="8073605" y="2212065"/>
                  <a:ext cx="1821076" cy="1770673"/>
                </a:xfrm>
                <a:prstGeom prst="rect">
                  <a:avLst/>
                </a:prstGeom>
              </p:spPr>
            </p:pic>
          </p:grpSp>
          <p:sp>
            <p:nvSpPr>
              <p:cNvPr id="19" name="TextBox 18"/>
              <p:cNvSpPr txBox="1"/>
              <p:nvPr/>
            </p:nvSpPr>
            <p:spPr>
              <a:xfrm>
                <a:off x="1476374" y="2743201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45’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358923" y="2723808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60’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397273" y="2713050"/>
                <a:ext cx="4095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90’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477978" y="2743200"/>
                <a:ext cx="4804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120’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9509014" y="2758190"/>
                <a:ext cx="4804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180’</a:t>
                </a:r>
              </a:p>
            </p:txBody>
          </p:sp>
        </p:grpSp>
        <p:cxnSp>
          <p:nvCxnSpPr>
            <p:cNvPr id="27" name="Straight Arrow Connector 26"/>
            <p:cNvCxnSpPr/>
            <p:nvPr/>
          </p:nvCxnSpPr>
          <p:spPr>
            <a:xfrm>
              <a:off x="629773" y="4914900"/>
              <a:ext cx="1399052" cy="9525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933450" y="4945694"/>
              <a:ext cx="8667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Stat3</a:t>
              </a: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323376" y="5387918"/>
            <a:ext cx="109669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9: Time kinetics of p-STAT3 expression in RA CD4</a:t>
            </a:r>
            <a:r>
              <a:rPr lang="en-US" sz="16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histogram plots did not show any significant expression of p-STAT3 in RA CD4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ith PMA/Ionomycin stimulation at various time points, ranging from 5 minutes to 180 minutes.</a:t>
            </a:r>
          </a:p>
        </p:txBody>
      </p:sp>
    </p:spTree>
    <p:extLst>
      <p:ext uri="{BB962C8B-B14F-4D97-AF65-F5344CB8AC3E}">
        <p14:creationId xmlns:p14="http://schemas.microsoft.com/office/powerpoint/2010/main" val="4095580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9</TotalTime>
  <Words>698</Words>
  <Application>Microsoft Office PowerPoint</Application>
  <PresentationFormat>Widescreen</PresentationFormat>
  <Paragraphs>82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adas</dc:creator>
  <cp:lastModifiedBy>gargee1308@gmail.com</cp:lastModifiedBy>
  <cp:revision>40</cp:revision>
  <dcterms:created xsi:type="dcterms:W3CDTF">2023-03-06T21:21:27Z</dcterms:created>
  <dcterms:modified xsi:type="dcterms:W3CDTF">2023-08-25T15:56:59Z</dcterms:modified>
</cp:coreProperties>
</file>